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3964B1-034D-4CFE-A59B-E9B408D389D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8D2B41-7C4F-45B9-9D54-18FC6CC5502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EAF936-3D8F-459F-AC64-0E987B88A56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EB316D-25E8-4D00-93B3-958DCA7BF9C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C8ECF0-ECF1-4A0F-BB64-50F42AB68D0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226301-8CDB-4BF2-8561-00E4B77F1C0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787664-0BE2-47C0-AFF8-52B9FE1FBD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F5CFBB-6D4E-4EE0-9AE4-D8617E1C67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B6843A-6F9A-488D-BF2F-6B6AC3008A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5CD180-0DAA-457C-970E-969D8F4D43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C89697-DF21-4F61-8E42-1D83D98DB5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9D7634-2238-4E8B-AC0B-E95070C83E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C1995E4-F079-4F7A-8FDD-136818AE821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609480" y="1084320"/>
            <a:ext cx="7848720" cy="475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How to calculate it in DAVID?</a:t>
            </a:r>
            <a:br>
              <a:rPr sz="1800"/>
            </a:b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or an example:</a:t>
            </a:r>
            <a:br>
              <a:rPr sz="1800"/>
            </a:br>
            <a:br>
              <a:rPr sz="1800"/>
            </a:b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nnotation Cluster1</a:t>
            </a:r>
            <a:br>
              <a:rPr sz="1800"/>
            </a:b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erms                                   EASE Score (Fisher Exact P-value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NA binding ...........................2.6E-7</a:t>
            </a:r>
            <a:br>
              <a:rPr sz="1800"/>
            </a:b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ranscription............................1.3E-6</a:t>
            </a:r>
            <a:br>
              <a:rPr sz="1800"/>
            </a:b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ranscription regulation...........1.2E-5</a:t>
            </a:r>
            <a:br>
              <a:rPr sz="1800"/>
            </a:br>
            <a:br>
              <a:rPr sz="1800"/>
            </a:b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hen, the enrichment geometric mean = 3rd root of (2.6E-7)*(1.3E-6) *(1.2E-5) = 1.6E-6</a:t>
            </a:r>
            <a:br>
              <a:rPr sz="1800"/>
            </a:b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herefore, by our definition, the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enrichment score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= -log(1.6E-6) =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5.8</a:t>
            </a:r>
            <a:br>
              <a:rPr sz="1800"/>
            </a:br>
            <a:br>
              <a:rPr sz="1800"/>
            </a:b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533520" y="380880"/>
            <a:ext cx="7086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ntroduction of the Enrichment Score of Annotation Cluste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0-10T19:03:23Z</dcterms:created>
  <dc:creator>DaWei Huang</dc:creator>
  <dc:description/>
  <dc:language>en-US</dc:language>
  <cp:lastModifiedBy>DaWei Huang</cp:lastModifiedBy>
  <dcterms:modified xsi:type="dcterms:W3CDTF">2006-10-10T19:10:40Z</dcterms:modified>
  <cp:revision>2</cp:revision>
  <dc:subject/>
  <dc:title>Slide 1</dc:title>
</cp:coreProperties>
</file>